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40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SDHD 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4yxd_D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4ysx_D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00034" y="71414"/>
            <a:ext cx="3314401" cy="30670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142852"/>
            <a:ext cx="3600450" cy="292895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0034" y="3214686"/>
            <a:ext cx="3286148" cy="27868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8142" y="3214686"/>
            <a:ext cx="3568700" cy="285273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84</cp:revision>
  <dcterms:created xsi:type="dcterms:W3CDTF">2018-05-10T07:33:24Z</dcterms:created>
  <dcterms:modified xsi:type="dcterms:W3CDTF">2018-05-29T07:45:03Z</dcterms:modified>
</cp:coreProperties>
</file>